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Средний стиль 2 — акцент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82638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87970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17651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57838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79279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33190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97028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9650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16189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44954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47958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1246E-459F-49F3-9BEA-B64C8C64C202}" type="datetimeFigureOut">
              <a:rPr lang="ru-RU" smtClean="0"/>
              <a:t>30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8DF1F3-8C68-4349-9CBF-8C065E49BCD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0524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Рисунок 17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7998" y="537293"/>
            <a:ext cx="2894965" cy="2846705"/>
          </a:xfrm>
          <a:prstGeom prst="rect">
            <a:avLst/>
          </a:prstGeom>
          <a:noFill/>
          <a:ln>
            <a:noFill/>
          </a:ln>
        </p:spPr>
      </p:pic>
      <p:pic>
        <p:nvPicPr>
          <p:cNvPr id="19" name="Рисунок 18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2961" y="565868"/>
            <a:ext cx="3061970" cy="282702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Рисунок 19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7997" y="3364313"/>
            <a:ext cx="2894965" cy="284607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Рисунок 20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2962" y="3364313"/>
            <a:ext cx="3101975" cy="2863850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Прямоугольник 7"/>
          <p:cNvSpPr/>
          <p:nvPr/>
        </p:nvSpPr>
        <p:spPr>
          <a:xfrm>
            <a:off x="2013063" y="150181"/>
            <a:ext cx="13388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MelCS</a:t>
            </a:r>
            <a:r>
              <a:rPr lang="en-US" b="1" baseline="30000" dirty="0" smtClean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12</a:t>
            </a:r>
            <a:endParaRPr lang="ru-RU" dirty="0"/>
          </a:p>
        </p:txBody>
      </p:sp>
      <p:sp>
        <p:nvSpPr>
          <p:cNvPr id="9" name="Прямоугольник 8"/>
          <p:cNvSpPr/>
          <p:nvPr/>
        </p:nvSpPr>
        <p:spPr>
          <a:xfrm>
            <a:off x="4923004" y="150181"/>
            <a:ext cx="12618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MelPlus</a:t>
            </a:r>
            <a:endParaRPr lang="ru-RU" dirty="0"/>
          </a:p>
        </p:txBody>
      </p:sp>
      <p:pic>
        <p:nvPicPr>
          <p:cNvPr id="24" name="Рисунок 23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1093" y="6367120"/>
            <a:ext cx="4831080" cy="362585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Прямоугольник 1"/>
          <p:cNvSpPr/>
          <p:nvPr/>
        </p:nvSpPr>
        <p:spPr>
          <a:xfrm>
            <a:off x="5807334" y="2085836"/>
            <a:ext cx="6096000" cy="2753061"/>
          </a:xfrm>
          <a:prstGeom prst="rect">
            <a:avLst/>
          </a:prstGeom>
        </p:spPr>
        <p:txBody>
          <a:bodyPr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4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actions of reads, belonging to different sources in the 4 sequenced </a:t>
            </a:r>
            <a:r>
              <a:rPr lang="en-US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es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taining </a:t>
            </a:r>
            <a:r>
              <a:rPr lang="en-US" sz="1400" i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lbachia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s wMelCS</a:t>
            </a:r>
            <a:r>
              <a:rPr lang="en-US" sz="14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12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, C) and </a:t>
            </a:r>
            <a:r>
              <a:rPr lang="en-US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MelPlus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B, D</a:t>
            </a:r>
            <a:r>
              <a:rPr lang="en-US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tracted from 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. melanogaster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varies without </a:t>
            </a:r>
            <a:r>
              <a:rPr lang="en-US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use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a filter (A, B) and from whole females with </a:t>
            </a:r>
            <a:r>
              <a:rPr lang="en-US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use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a filter (C, D). Human – hg38 human genome assembly; 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. melanogaster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t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- 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rosophila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m6 genome assembly, excluding mitochondria; dm6 mitochondria - mitochondrial genome taken from the 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rosophila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m6 genome assembly; Synthetic - synthetic sequences included in the </a:t>
            </a:r>
            <a:r>
              <a:rPr lang="en-US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iVec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atabase; </a:t>
            </a:r>
            <a:r>
              <a:rPr lang="en-US" sz="1400" i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lbachia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?) presumably </a:t>
            </a:r>
            <a:r>
              <a:rPr lang="en-US" sz="1400" i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lbachia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uences.</a:t>
            </a:r>
            <a:endParaRPr lang="ru-RU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784574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16</Words>
  <Application>Microsoft Office PowerPoint</Application>
  <PresentationFormat>Широкоэкранный</PresentationFormat>
  <Paragraphs>3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6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Palatino Linotype</vt:lpstr>
      <vt:lpstr>Times New Roman</vt:lpstr>
      <vt:lpstr>Тема Office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yasana</dc:creator>
  <cp:lastModifiedBy>nataly</cp:lastModifiedBy>
  <cp:revision>3</cp:revision>
  <dcterms:created xsi:type="dcterms:W3CDTF">2022-11-30T05:20:31Z</dcterms:created>
  <dcterms:modified xsi:type="dcterms:W3CDTF">2022-11-30T11:46:25Z</dcterms:modified>
</cp:coreProperties>
</file>